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1"/>
    <p:restoredTop sz="94653"/>
  </p:normalViewPr>
  <p:slideViewPr>
    <p:cSldViewPr snapToGrid="0">
      <p:cViewPr varScale="1">
        <p:scale>
          <a:sx n="88" d="100"/>
          <a:sy n="88" d="100"/>
        </p:scale>
        <p:origin x="288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FD6A5F2-CFE8-D1C9-2229-3896DA2591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ACD6C09D-7426-0857-75BA-DF3EF0661A2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FE5BE40-CC2D-3499-72B2-5E05641554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90442-3A9B-9946-9267-110FA59B6BFA}" type="datetimeFigureOut">
              <a:rPr lang="de-DE" smtClean="0"/>
              <a:t>20.1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7688C46-6D65-F084-07DA-B556295C67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45D7555-5207-5F03-A278-5066A2C63A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6236A-2F42-AD40-9F02-C0201D5F77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2738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3E2FCD0-8980-CF12-FBE7-DC5A8C61FD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333174CD-9549-5037-EC85-6AD1BF881C6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FD3B84D-1312-359D-4BC0-52EE1F5E9F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90442-3A9B-9946-9267-110FA59B6BFA}" type="datetimeFigureOut">
              <a:rPr lang="de-DE" smtClean="0"/>
              <a:t>20.1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54FD7565-B94E-AB44-63A2-AB4C84E864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37F09F8-6E96-ECB4-B563-D6ABC250B0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6236A-2F42-AD40-9F02-C0201D5F77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9881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0E2772A9-F198-A6D0-2739-17271C86597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ED76BE87-BA7C-A2BA-AD5B-6076950669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22A4724-7109-A052-36F7-1E4C2F0222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90442-3A9B-9946-9267-110FA59B6BFA}" type="datetimeFigureOut">
              <a:rPr lang="de-DE" smtClean="0"/>
              <a:t>20.1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7B77812-5A70-4C1E-4496-4D6988E96B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C3239C5-A932-6D41-AEF2-D1818C3E7E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6236A-2F42-AD40-9F02-C0201D5F77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00130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56BDA9F-5410-D7E6-6BA3-7C437327ECC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CA082B76-B239-B17A-3029-2883037AD22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DF4506C-E8B7-A6E5-9E82-C7158BBF23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90442-3A9B-9946-9267-110FA59B6BFA}" type="datetimeFigureOut">
              <a:rPr lang="de-DE" smtClean="0"/>
              <a:t>20.1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6331F11-6914-FEBB-BD9B-C78A04F5DD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1A66356-D08D-A075-6EA8-E18110F072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6236A-2F42-AD40-9F02-C0201D5F77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272087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2226699-31DA-CB89-D883-2416C772F9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5FD8FF4-763F-23E9-0984-DD6AD90A7D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5D6B6FD-A8BE-82CD-3DA7-6C9CFB2F0C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90442-3A9B-9946-9267-110FA59B6BFA}" type="datetimeFigureOut">
              <a:rPr lang="de-DE" smtClean="0"/>
              <a:t>20.1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8F29E25-4B19-1741-C08C-7EB2029C8E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717087A-B32B-7DF3-6977-6A528C98B0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6236A-2F42-AD40-9F02-C0201D5F77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163651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7AC4385-FCBB-2461-C4B0-7EF4F6986F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5EC67F5-5899-A040-96F9-CD5931938F4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9842137-A7A2-BD5A-E298-0E70AB09E2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CDE5C93-723F-9322-B0E4-0DA44F7AA0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90442-3A9B-9946-9267-110FA59B6BFA}" type="datetimeFigureOut">
              <a:rPr lang="de-DE" smtClean="0"/>
              <a:t>20.11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0C747D60-E419-18E3-BEFF-36709D5B05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36CFC193-DDF6-9EC1-4CB3-D187FA2F5E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6236A-2F42-AD40-9F02-C0201D5F77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46270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F24F906-15AD-47B1-651D-643023D890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05EE455-8526-5A1A-A86D-85464D9792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4A62B56E-1494-C4AA-20FF-D28B3E5AD9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03D0F6B2-78DA-091B-1118-EFBDBD7308F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AA263F5F-DABC-1A36-2C5C-82DE575472A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09E8A80B-F0A2-4EF2-C7B0-93C5894389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90442-3A9B-9946-9267-110FA59B6BFA}" type="datetimeFigureOut">
              <a:rPr lang="de-DE" smtClean="0"/>
              <a:t>20.11.20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D7E459C9-ACDA-C5B5-1408-27F18265B0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2EA884B4-499B-E47C-5559-D9E0834C3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6236A-2F42-AD40-9F02-C0201D5F77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799130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657E38A-7BF8-B818-1DEA-F4CB2762AD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AD9457B7-FAB3-461B-DC12-C64F52EEAA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90442-3A9B-9946-9267-110FA59B6BFA}" type="datetimeFigureOut">
              <a:rPr lang="de-DE" smtClean="0"/>
              <a:t>20.11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2FB4F708-A374-67FD-056E-894AB11BE9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68125DB6-3A36-819E-BF64-DDC76DCF0D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6236A-2F42-AD40-9F02-C0201D5F77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44140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2E2B800B-1748-5511-D874-F1375CDDBA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90442-3A9B-9946-9267-110FA59B6BFA}" type="datetimeFigureOut">
              <a:rPr lang="de-DE" smtClean="0"/>
              <a:t>20.11.20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6CE2ED92-E799-6C1B-DF9E-FFFC16E324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FBB4EE7B-3F9A-C0A8-1CEC-D384815AD4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6236A-2F42-AD40-9F02-C0201D5F77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795344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F19DE98-036D-DC77-08E4-237A598C6A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0E97CBB7-2A4A-AE91-66EC-61DA6F14D56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E59CD175-5BA2-6BED-E9BD-0E165AF807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9F74480-9220-06C2-4035-6B0474D8FF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90442-3A9B-9946-9267-110FA59B6BFA}" type="datetimeFigureOut">
              <a:rPr lang="de-DE" smtClean="0"/>
              <a:t>20.11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D33E0CA-2C10-F89F-B30F-281963739A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BDACC0E-B7BA-E374-EBF5-C93FCD485B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6236A-2F42-AD40-9F02-C0201D5F77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2645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B3CB5C0-E77E-7498-2FCA-AD614009CB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F0C53A5B-7371-51B3-74CB-5C0FEC84C6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E84476F-2D8C-1E01-D6E0-1A2844009E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7CF40DF7-0C16-27B7-59AB-CA0A72B5AF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C90442-3A9B-9946-9267-110FA59B6BFA}" type="datetimeFigureOut">
              <a:rPr lang="de-DE" smtClean="0"/>
              <a:t>20.11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CD59A1F-2018-FB2D-6CEE-C3CAB7CA46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AC9CEF7-059F-D88E-6DEB-485B3451C5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76236A-2F42-AD40-9F02-C0201D5F77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70435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156F1439-A1FD-66D5-3EA6-379B95C56E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3324B83-BD1F-8C0E-F6F6-5CCADE09C4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D510476-FFC2-822A-E961-CD0240734E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C90442-3A9B-9946-9267-110FA59B6BFA}" type="datetimeFigureOut">
              <a:rPr lang="de-DE" smtClean="0"/>
              <a:t>20.11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E9135A5-01C0-0806-D4F6-4372A390A6F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A0FAAAF-13AC-C5EA-F731-5A67E0D8C98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76236A-2F42-AD40-9F02-C0201D5F77F8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326233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>
            <a:extLst>
              <a:ext uri="{FF2B5EF4-FFF2-40B4-BE49-F238E27FC236}">
                <a16:creationId xmlns:a16="http://schemas.microsoft.com/office/drawing/2014/main" id="{36307E7F-F9B7-473C-6CAD-A5C465A0885B}"/>
              </a:ext>
            </a:extLst>
          </p:cNvPr>
          <p:cNvSpPr/>
          <p:nvPr/>
        </p:nvSpPr>
        <p:spPr>
          <a:xfrm>
            <a:off x="2141036" y="740883"/>
            <a:ext cx="3813715" cy="483472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C455C5E8-5770-29F7-7A97-0AE42314CC70}"/>
              </a:ext>
            </a:extLst>
          </p:cNvPr>
          <p:cNvSpPr txBox="1"/>
          <p:nvPr/>
        </p:nvSpPr>
        <p:spPr>
          <a:xfrm>
            <a:off x="2302727" y="958263"/>
            <a:ext cx="32561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[</a:t>
            </a:r>
            <a:r>
              <a:rPr lang="en-US" sz="1600" b="1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68</a:t>
            </a:r>
            <a:r>
              <a:rPr lang="en-US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a]Ga-FAPI-46 PET/CT</a:t>
            </a:r>
            <a:r>
              <a:rPr lang="de-DE" sz="1600" b="1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Pfeil nach rechts 6">
            <a:extLst>
              <a:ext uri="{FF2B5EF4-FFF2-40B4-BE49-F238E27FC236}">
                <a16:creationId xmlns:a16="http://schemas.microsoft.com/office/drawing/2014/main" id="{4C122B12-8ED0-532B-06FA-E8E7EB14402A}"/>
              </a:ext>
            </a:extLst>
          </p:cNvPr>
          <p:cNvSpPr/>
          <p:nvPr/>
        </p:nvSpPr>
        <p:spPr>
          <a:xfrm rot="5400000">
            <a:off x="3379371" y="1779171"/>
            <a:ext cx="816904" cy="285965"/>
          </a:xfrm>
          <a:prstGeom prst="rightArrow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tx1"/>
              </a:solidFill>
            </a:endParaRP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CE93A27B-28AC-763B-48A1-7BBC91F600FB}"/>
              </a:ext>
            </a:extLst>
          </p:cNvPr>
          <p:cNvSpPr txBox="1"/>
          <p:nvPr/>
        </p:nvSpPr>
        <p:spPr>
          <a:xfrm>
            <a:off x="4025590" y="1485065"/>
            <a:ext cx="1929161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Time difference between PET and surgery: maximum 40 days</a:t>
            </a:r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509AB54A-98DF-180A-B6C5-1851CD44267F}"/>
              </a:ext>
            </a:extLst>
          </p:cNvPr>
          <p:cNvSpPr txBox="1"/>
          <p:nvPr/>
        </p:nvSpPr>
        <p:spPr>
          <a:xfrm>
            <a:off x="2302727" y="2547738"/>
            <a:ext cx="325615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adical cystectomy with locoregional lymphadenectomy 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Pfeil nach rechts 9">
            <a:extLst>
              <a:ext uri="{FF2B5EF4-FFF2-40B4-BE49-F238E27FC236}">
                <a16:creationId xmlns:a16="http://schemas.microsoft.com/office/drawing/2014/main" id="{17C60402-C1B6-7B7D-C6C0-D13CB91B2964}"/>
              </a:ext>
            </a:extLst>
          </p:cNvPr>
          <p:cNvSpPr/>
          <p:nvPr/>
        </p:nvSpPr>
        <p:spPr>
          <a:xfrm rot="5400000">
            <a:off x="3379370" y="3627675"/>
            <a:ext cx="816904" cy="285965"/>
          </a:xfrm>
          <a:prstGeom prst="rightArrow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tx1"/>
              </a:solidFill>
            </a:endParaRPr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8FEF8DF2-6895-4160-2ACD-3262DA9FB61D}"/>
              </a:ext>
            </a:extLst>
          </p:cNvPr>
          <p:cNvSpPr txBox="1"/>
          <p:nvPr/>
        </p:nvSpPr>
        <p:spPr>
          <a:xfrm>
            <a:off x="2397512" y="4267081"/>
            <a:ext cx="3256156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6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rrelation of FAPI-uptake and histopathological results in the locoregional lymph node regions</a:t>
            </a:r>
            <a:endParaRPr lang="de-DE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03813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</Words>
  <Application>Microsoft Office PowerPoint</Application>
  <PresentationFormat>Breitbild</PresentationFormat>
  <Paragraphs>4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ena Mittlmeier</dc:creator>
  <cp:lastModifiedBy>Unterrainer, Lena PD Dr.med.</cp:lastModifiedBy>
  <cp:revision>4</cp:revision>
  <dcterms:created xsi:type="dcterms:W3CDTF">2023-11-19T19:56:48Z</dcterms:created>
  <dcterms:modified xsi:type="dcterms:W3CDTF">2023-11-20T08:04:00Z</dcterms:modified>
</cp:coreProperties>
</file>